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EC5F11-FF2A-4EC8-B3AB-EC1380D4F0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C1B87-4432-4C1E-A7D0-FF07491FAE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5CB4C-F818-4D54-A2B2-2CD2192AF8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EED76B-F787-4A75-80DD-D2CAA57C90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FB07C-952D-4C3C-BEFF-20202BE9C9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12F97-DEE2-4D47-B0E2-64C0322336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B4B04-2F83-4698-A9A1-36C8D36FA9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EC06B-C782-40E2-B846-9023330459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F92CC-C521-4E91-ADA2-F593BB4F78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3914A-504B-4224-9A05-BF93704BA4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8FC00-E63E-4917-82E3-4646EF6C64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6DA3D-393B-43B5-97DB-F0F0751DF8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E1FBE5-FEB0-4150-8AE5-D2B81B85F79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4723920"/>
            <a:ext cx="8229600" cy="175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4: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aplan-Meir plots show (a) subjects with higher UACR (&gt;median 192 µg/g of creatinine) were at higher risk of developing arsenic-induced skin lesion than those with lower UACR (p=0.001, log rank test; shown on left side); (b) categorization by well water arsenic (WAs) also showed similar effect – higher risk in subjects drinking water with higher arsenic concentration (&gt;median 56 µg/L) compared to those drinking water with lower arsenic concentration (p=1.97 E-09, log rank test; shown on right side). X-axis represents time to event (months of follow-up after enrollment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4038480" cy="32324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" descr=""/>
          <p:cNvPicPr/>
          <p:nvPr/>
        </p:nvPicPr>
        <p:blipFill>
          <a:blip r:embed="rId2"/>
          <a:stretch/>
        </p:blipFill>
        <p:spPr>
          <a:xfrm>
            <a:off x="4648320" y="1295280"/>
            <a:ext cx="4038480" cy="3232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3T22:36:52Z</dcterms:created>
  <dc:creator>mkibriya</dc:creator>
  <dc:description/>
  <dc:language>en-US</dc:language>
  <cp:lastModifiedBy>mkibriya</cp:lastModifiedBy>
  <dcterms:modified xsi:type="dcterms:W3CDTF">2017-03-29T18:44:40Z</dcterms:modified>
  <cp:revision>35</cp:revision>
  <dc:subject/>
  <dc:title>Slide 1</dc:title>
</cp:coreProperties>
</file>